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7" autoAdjust="0"/>
    <p:restoredTop sz="94660"/>
  </p:normalViewPr>
  <p:slideViewPr>
    <p:cSldViewPr snapToGrid="0">
      <p:cViewPr>
        <p:scale>
          <a:sx n="42" d="100"/>
          <a:sy n="42" d="100"/>
        </p:scale>
        <p:origin x="3090" y="9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0F1C5-007A-43F3-98AC-DE974B024176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AE63-FC58-4628-8265-8B7BCE5EA7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58048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0F1C5-007A-43F3-98AC-DE974B024176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AE63-FC58-4628-8265-8B7BCE5EA7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2398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0F1C5-007A-43F3-98AC-DE974B024176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AE63-FC58-4628-8265-8B7BCE5EA7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19570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0F1C5-007A-43F3-98AC-DE974B024176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AE63-FC58-4628-8265-8B7BCE5EA7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40918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0F1C5-007A-43F3-98AC-DE974B024176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AE63-FC58-4628-8265-8B7BCE5EA7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43875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0F1C5-007A-43F3-98AC-DE974B024176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AE63-FC58-4628-8265-8B7BCE5EA7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39812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0F1C5-007A-43F3-98AC-DE974B024176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AE63-FC58-4628-8265-8B7BCE5EA7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3117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0F1C5-007A-43F3-98AC-DE974B024176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AE63-FC58-4628-8265-8B7BCE5EA7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50645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0F1C5-007A-43F3-98AC-DE974B024176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AE63-FC58-4628-8265-8B7BCE5EA7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20462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0F1C5-007A-43F3-98AC-DE974B024176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AE63-FC58-4628-8265-8B7BCE5EA7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180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0F1C5-007A-43F3-98AC-DE974B024176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AE63-FC58-4628-8265-8B7BCE5EA7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87494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F0F1C5-007A-43F3-98AC-DE974B024176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F3AE63-FC58-4628-8265-8B7BCE5EA7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7469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TextBox 67">
            <a:extLst>
              <a:ext uri="{FF2B5EF4-FFF2-40B4-BE49-F238E27FC236}">
                <a16:creationId xmlns:a16="http://schemas.microsoft.com/office/drawing/2014/main" id="{DBBB1586-3A72-83FA-54E3-9EA22EC0EDD6}"/>
              </a:ext>
            </a:extLst>
          </p:cNvPr>
          <p:cNvSpPr txBox="1"/>
          <p:nvPr/>
        </p:nvSpPr>
        <p:spPr>
          <a:xfrm>
            <a:off x="2191171" y="109866"/>
            <a:ext cx="258275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1-source data 2</a:t>
            </a:r>
          </a:p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LA</a:t>
            </a:r>
          </a:p>
        </p:txBody>
      </p:sp>
      <p:pic>
        <p:nvPicPr>
          <p:cNvPr id="67" name="Picture 66">
            <a:extLst>
              <a:ext uri="{FF2B5EF4-FFF2-40B4-BE49-F238E27FC236}">
                <a16:creationId xmlns:a16="http://schemas.microsoft.com/office/drawing/2014/main" id="{A2E0290B-EB81-FB8C-9792-4E2FC53B40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5684" y="1167210"/>
            <a:ext cx="5492351" cy="10864770"/>
          </a:xfrm>
          <a:prstGeom prst="rect">
            <a:avLst/>
          </a:prstGeom>
        </p:spPr>
      </p:pic>
      <p:sp>
        <p:nvSpPr>
          <p:cNvPr id="71" name="TextBox 70">
            <a:extLst>
              <a:ext uri="{FF2B5EF4-FFF2-40B4-BE49-F238E27FC236}">
                <a16:creationId xmlns:a16="http://schemas.microsoft.com/office/drawing/2014/main" id="{17E22743-4056-797A-0FDE-EF5DFB1173B7}"/>
              </a:ext>
            </a:extLst>
          </p:cNvPr>
          <p:cNvSpPr txBox="1"/>
          <p:nvPr/>
        </p:nvSpPr>
        <p:spPr>
          <a:xfrm>
            <a:off x="150011" y="1560314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OIL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A9FF480C-71C5-08CB-F629-EF78A3177C8F}"/>
              </a:ext>
            </a:extLst>
          </p:cNvPr>
          <p:cNvSpPr txBox="1"/>
          <p:nvPr/>
        </p:nvSpPr>
        <p:spPr>
          <a:xfrm>
            <a:off x="-38430" y="3130834"/>
            <a:ext cx="7441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CL</a:t>
            </a:r>
            <a:r>
              <a:rPr lang="en-US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2B485F6C-C73E-CCDD-08D5-73AF246A14E1}"/>
              </a:ext>
            </a:extLst>
          </p:cNvPr>
          <p:cNvSpPr txBox="1"/>
          <p:nvPr/>
        </p:nvSpPr>
        <p:spPr>
          <a:xfrm>
            <a:off x="7126" y="5710387"/>
            <a:ext cx="7441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CL</a:t>
            </a:r>
            <a:r>
              <a:rPr lang="en-US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EE5D6D73-AD0E-4964-7A47-AD14ACD2015B}"/>
              </a:ext>
            </a:extLst>
          </p:cNvPr>
          <p:cNvSpPr txBox="1"/>
          <p:nvPr/>
        </p:nvSpPr>
        <p:spPr>
          <a:xfrm>
            <a:off x="-15406" y="8713763"/>
            <a:ext cx="7441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CL</a:t>
            </a:r>
            <a:r>
              <a:rPr lang="en-US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C03B7C87-69D0-6B07-A09E-93C42AB08F9B}"/>
              </a:ext>
            </a:extLst>
          </p:cNvPr>
          <p:cNvSpPr txBox="1"/>
          <p:nvPr/>
        </p:nvSpPr>
        <p:spPr>
          <a:xfrm>
            <a:off x="30150" y="11293316"/>
            <a:ext cx="7441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CL</a:t>
            </a:r>
            <a:r>
              <a:rPr lang="en-US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C37A35B2-B8C1-B4A4-5DF1-47EB9F11E47E}"/>
              </a:ext>
            </a:extLst>
          </p:cNvPr>
          <p:cNvSpPr txBox="1"/>
          <p:nvPr/>
        </p:nvSpPr>
        <p:spPr>
          <a:xfrm>
            <a:off x="142391" y="4364474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OIL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071F650A-89C7-D1EF-1584-9E6E01AAC2A8}"/>
              </a:ext>
            </a:extLst>
          </p:cNvPr>
          <p:cNvSpPr txBox="1"/>
          <p:nvPr/>
        </p:nvSpPr>
        <p:spPr>
          <a:xfrm>
            <a:off x="134771" y="7145774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OIL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AA15EEB2-05D3-2B56-857E-C9C5107DA48A}"/>
              </a:ext>
            </a:extLst>
          </p:cNvPr>
          <p:cNvSpPr txBox="1"/>
          <p:nvPr/>
        </p:nvSpPr>
        <p:spPr>
          <a:xfrm>
            <a:off x="150011" y="9835634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OIL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DAC4A1CC-07F9-B931-AFBE-C881AB3AD99F}"/>
              </a:ext>
            </a:extLst>
          </p:cNvPr>
          <p:cNvSpPr txBox="1"/>
          <p:nvPr/>
        </p:nvSpPr>
        <p:spPr>
          <a:xfrm>
            <a:off x="1005840" y="784328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4C096AF7-AA44-1262-3707-FF62E3C78563}"/>
              </a:ext>
            </a:extLst>
          </p:cNvPr>
          <p:cNvSpPr txBox="1"/>
          <p:nvPr/>
        </p:nvSpPr>
        <p:spPr>
          <a:xfrm>
            <a:off x="3545518" y="790826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ESMIN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61D3DD65-B747-DBA8-9795-D3D5304B143C}"/>
              </a:ext>
            </a:extLst>
          </p:cNvPr>
          <p:cNvSpPr txBox="1"/>
          <p:nvPr/>
        </p:nvSpPr>
        <p:spPr>
          <a:xfrm>
            <a:off x="2124542" y="797878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-AKAP12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E24D809B-09AD-5031-CC51-CB4059BF90F7}"/>
              </a:ext>
            </a:extLst>
          </p:cNvPr>
          <p:cNvSpPr txBox="1"/>
          <p:nvPr/>
        </p:nvSpPr>
        <p:spPr>
          <a:xfrm>
            <a:off x="4885906" y="793486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</a:p>
        </p:txBody>
      </p:sp>
    </p:spTree>
    <p:extLst>
      <p:ext uri="{BB962C8B-B14F-4D97-AF65-F5344CB8AC3E}">
        <p14:creationId xmlns:p14="http://schemas.microsoft.com/office/powerpoint/2010/main" val="8450125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25847A7-45CB-CB83-DBDB-9DC89638FE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76498" y="937260"/>
            <a:ext cx="1505004" cy="1086307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77BDEC3-6A8B-5C34-E761-316494C80310}"/>
              </a:ext>
            </a:extLst>
          </p:cNvPr>
          <p:cNvSpPr txBox="1"/>
          <p:nvPr/>
        </p:nvSpPr>
        <p:spPr>
          <a:xfrm>
            <a:off x="2024531" y="1331714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OIL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ED62894-B00B-5BDA-D807-38F4C05F16BA}"/>
              </a:ext>
            </a:extLst>
          </p:cNvPr>
          <p:cNvSpPr txBox="1"/>
          <p:nvPr/>
        </p:nvSpPr>
        <p:spPr>
          <a:xfrm>
            <a:off x="1836090" y="2902234"/>
            <a:ext cx="7441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CL</a:t>
            </a:r>
            <a:r>
              <a:rPr lang="en-US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9CF6CD4-BC1A-2C6B-4AC2-40034608EA8D}"/>
              </a:ext>
            </a:extLst>
          </p:cNvPr>
          <p:cNvSpPr txBox="1"/>
          <p:nvPr/>
        </p:nvSpPr>
        <p:spPr>
          <a:xfrm>
            <a:off x="1881646" y="5481787"/>
            <a:ext cx="7441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CL</a:t>
            </a:r>
            <a:r>
              <a:rPr lang="en-US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FAB0939-8AE1-93F5-31E9-CDD1E6D28488}"/>
              </a:ext>
            </a:extLst>
          </p:cNvPr>
          <p:cNvSpPr txBox="1"/>
          <p:nvPr/>
        </p:nvSpPr>
        <p:spPr>
          <a:xfrm>
            <a:off x="1859114" y="8233703"/>
            <a:ext cx="7441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CL</a:t>
            </a:r>
            <a:r>
              <a:rPr lang="en-US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6AF979E-3FFB-3291-F75C-80F728BD4140}"/>
              </a:ext>
            </a:extLst>
          </p:cNvPr>
          <p:cNvSpPr txBox="1"/>
          <p:nvPr/>
        </p:nvSpPr>
        <p:spPr>
          <a:xfrm>
            <a:off x="1904670" y="11064716"/>
            <a:ext cx="7441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CL</a:t>
            </a:r>
            <a:r>
              <a:rPr lang="en-US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242A4FD-96A3-5C0C-B688-D7C384E3F2A1}"/>
              </a:ext>
            </a:extLst>
          </p:cNvPr>
          <p:cNvSpPr txBox="1"/>
          <p:nvPr/>
        </p:nvSpPr>
        <p:spPr>
          <a:xfrm>
            <a:off x="2016911" y="4135874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OI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4A165AC-BF4C-CE29-CFC4-C4110DAC07E7}"/>
              </a:ext>
            </a:extLst>
          </p:cNvPr>
          <p:cNvSpPr txBox="1"/>
          <p:nvPr/>
        </p:nvSpPr>
        <p:spPr>
          <a:xfrm>
            <a:off x="2009291" y="6917174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OI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6238BA4-315C-2D6C-C075-240CE4125EC9}"/>
              </a:ext>
            </a:extLst>
          </p:cNvPr>
          <p:cNvSpPr txBox="1"/>
          <p:nvPr/>
        </p:nvSpPr>
        <p:spPr>
          <a:xfrm>
            <a:off x="2024531" y="9607034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OIL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95AAFFE-90CD-6867-ADBC-5CB7553AFA84}"/>
              </a:ext>
            </a:extLst>
          </p:cNvPr>
          <p:cNvSpPr txBox="1"/>
          <p:nvPr/>
        </p:nvSpPr>
        <p:spPr>
          <a:xfrm>
            <a:off x="2191171" y="178446"/>
            <a:ext cx="258275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1-source data 2</a:t>
            </a:r>
          </a:p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IHC staining</a:t>
            </a:r>
          </a:p>
        </p:txBody>
      </p:sp>
    </p:spTree>
    <p:extLst>
      <p:ext uri="{BB962C8B-B14F-4D97-AF65-F5344CB8AC3E}">
        <p14:creationId xmlns:p14="http://schemas.microsoft.com/office/powerpoint/2010/main" val="41679323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29</Words>
  <Application>Microsoft Office PowerPoint</Application>
  <PresentationFormat>Widescreen</PresentationFormat>
  <Paragraphs>2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mal Ramani</dc:creator>
  <cp:lastModifiedBy>Komal Ramani</cp:lastModifiedBy>
  <cp:revision>1</cp:revision>
  <dcterms:created xsi:type="dcterms:W3CDTF">2022-07-20T16:32:21Z</dcterms:created>
  <dcterms:modified xsi:type="dcterms:W3CDTF">2022-07-20T16:43:05Z</dcterms:modified>
</cp:coreProperties>
</file>